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FCE9B8-34F7-4301-AC92-AC244CB81D79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04A312-6215-47EC-8E60-ACD0E086E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8045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66F8E0-A3D8-4894-A605-51CD2E3C4B7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6618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EFE6A-6939-4551-9D78-A8A3CF4D4E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E2720F-ADBB-4304-8352-FD1B2082B0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179A5-A5EC-45B3-8329-8E1947BA2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5681A3-55EB-4F86-A9B8-0FE1667A2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3853B2-09D8-4985-8916-7E97D4AE8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59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D422FB-1B6E-4978-9C2C-2DD7C302D1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8AE688-B4F3-4454-AB98-E96AB70053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F69B18-574F-4830-BB19-BFA4611F4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C8F668-DCE7-4996-BA9B-BC18CC570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C7CE44-8CDE-47A5-9707-F5FE26747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702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9979B0-5825-4BCE-B419-EC789DF82F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1AFBA4-5F99-4762-8328-BB2001DF1D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24A88D-FEC5-4EB4-BF4E-7B8CAC273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3FC4A-5DDA-4B80-9F65-AF1FC83A2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A0E9F8-CFF1-4C92-A996-30011CB12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320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ED7BE-D762-400E-9066-0A23B0A4B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365F80-C04F-4C0C-9F0B-119D568977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07809-B06A-4CCF-9394-E0CEAFC4A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06CC9F-5A22-475F-80A0-B9E0FB995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8DF2E-7031-4BD7-8FBB-7692918D1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585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582EF-A75B-464B-BBB5-B3FFD23E2B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FB545B-9E4E-41EA-A67E-2CD8A3741C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8F285A-83D0-4373-A3B0-D9C2BB9DE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01FC75-E837-4512-BB1B-1A51261BB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93CF50-3583-4B19-A98B-6CBE99FF9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386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020AA1-E0FC-4CFE-9C6C-D4D35E797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7AAAB6-6E0B-48AC-A110-B86B57EBB4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774E21-2D98-4E9D-AE7F-26C8F8F59D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6A50BD-7C2A-488C-9836-5791372ED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548142-24F4-42AB-BBD1-9923BC829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3BE69A-0873-4344-BB97-FE3B1ECC9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508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CD870-387E-491B-B7CE-52929C3152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A1CB03-E62A-4D97-BBC8-B6E0895596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731D5C-CF58-4B3A-83B3-6722ACDBFE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2434F2-C621-486B-BBC6-C0360F21F8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826B6E-AD6B-4BD6-987C-6D0D5AB0FC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117DB5-374D-42F7-93BE-B6703D6CD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8EAEC0-39F5-418F-A3F6-5AF06A333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F26BFB-C418-4142-B3EF-F504247FF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349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F70ABB-BF8B-4ABA-9565-B53BF5F856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B1E246-F52B-48D3-88EC-988A3CCE1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D19600-8884-421F-BF72-4CB9DBE52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F8600F-35A0-4BB4-A9A6-ACE314375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494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107E96-1DBC-4238-9A47-C88878110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7707DA-9A49-4584-B1CA-5C69CDDE0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79BAA2-156F-4F20-9CE5-3AA0C9D15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22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752085-890C-4151-9B13-89096244C5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8B6414-8CF4-4BD8-ACE6-6ED6951278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EC2855-166D-4954-9F6E-D90E3497AA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C03E5B-E3FF-4118-81EC-2DFE6F06E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AC7ABC-BE45-42B1-A70E-95E72036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8AEB4-E40B-4ACE-BD1F-71B9C7A15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709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68AB7E-4E23-4882-AC6C-F6354FAF2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161DE7-DCFE-4E1D-ADE0-3C70C657FE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F5A0E3-5BF9-4608-BE67-C6E2AAFE5B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FFB024-5432-4C29-AF79-3A3551F48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17F202-D4FE-4B3C-940E-4F8EA3C19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777898-F415-4674-95F2-7BA50D9C5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88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E4239B-F77E-4136-B0AE-11FE5FD7C7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40DF62-3235-413A-8DE4-012F424A10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8432AA-0FF7-40E7-9AC8-3A5F433AB9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B7F18-AE31-4C78-8B7F-CEC9173FD9A4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F2DEB0-F812-4AAE-9DDF-29A55D4477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009F8-A0FF-4F1F-B795-D3D78B8093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EDE32-A79A-4D5E-AB8C-43B3FC2C7B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657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76400" y="1207532"/>
            <a:ext cx="2514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Aged Stressed Worms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/>
          </p:nvPr>
        </p:nvGraphicFramePr>
        <p:xfrm>
          <a:off x="1666164" y="1587100"/>
          <a:ext cx="8849436" cy="3605142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0959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55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981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57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404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aramet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Mean 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T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an difference with Young Untreate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an difference with Young Untreated</a:t>
                      </a:r>
                      <a:r>
                        <a:rPr lang="en-US" sz="1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resence in plausible solutions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987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P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GC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x10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x10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x10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66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8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66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0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8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752600" y="152400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4 Table</a:t>
            </a:r>
          </a:p>
        </p:txBody>
      </p:sp>
    </p:spTree>
    <p:extLst>
      <p:ext uri="{BB962C8B-B14F-4D97-AF65-F5344CB8AC3E}">
        <p14:creationId xmlns:p14="http://schemas.microsoft.com/office/powerpoint/2010/main" val="4112530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Widescreen</PresentationFormat>
  <Paragraphs>8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itsaG</dc:creator>
  <cp:lastModifiedBy>LenitsaG</cp:lastModifiedBy>
  <cp:revision>2</cp:revision>
  <dcterms:created xsi:type="dcterms:W3CDTF">2018-07-16T16:33:23Z</dcterms:created>
  <dcterms:modified xsi:type="dcterms:W3CDTF">2018-07-18T16:53:09Z</dcterms:modified>
</cp:coreProperties>
</file>